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4E482-F12E-4807-9240-3F0B4FE1669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599323-E2CD-4074-8542-B95BF58812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41157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599323-E2CD-4074-8542-B95BF58812BD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9362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6066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9079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294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0238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9515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1956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6973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6812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293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7040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542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B5AD6-ED84-4C9E-822B-3A4889FC9FA8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9F886-E710-42AC-B418-AF04E3BE2D6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904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31" t="30085" r="51828" b="57766"/>
          <a:stretch/>
        </p:blipFill>
        <p:spPr>
          <a:xfrm>
            <a:off x="2877670" y="2380129"/>
            <a:ext cx="1292006" cy="645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84" t="29495" r="22789" b="58609"/>
          <a:stretch/>
        </p:blipFill>
        <p:spPr>
          <a:xfrm>
            <a:off x="4250358" y="2393577"/>
            <a:ext cx="1210235" cy="6320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51" t="55380" r="46953" b="32595"/>
          <a:stretch/>
        </p:blipFill>
        <p:spPr>
          <a:xfrm>
            <a:off x="2877671" y="3092824"/>
            <a:ext cx="1292006" cy="510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72" t="55380" r="18348" b="32595"/>
          <a:stretch/>
        </p:blipFill>
        <p:spPr>
          <a:xfrm>
            <a:off x="4250357" y="3092824"/>
            <a:ext cx="1210235" cy="510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4"/>
          <a:srcRect t="21155" b="11538"/>
          <a:stretch/>
        </p:blipFill>
        <p:spPr>
          <a:xfrm>
            <a:off x="2877670" y="3657602"/>
            <a:ext cx="1292006" cy="4706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5"/>
          <a:srcRect t="21155" b="11538"/>
          <a:stretch/>
        </p:blipFill>
        <p:spPr>
          <a:xfrm>
            <a:off x="4250357" y="3657602"/>
            <a:ext cx="1210235" cy="4706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9"/>
          <p:cNvSpPr txBox="1"/>
          <p:nvPr/>
        </p:nvSpPr>
        <p:spPr>
          <a:xfrm>
            <a:off x="5487487" y="2551810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451629" y="3201749"/>
            <a:ext cx="1175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GFR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483006" y="3676877"/>
            <a:ext cx="10038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CBL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97" t="39393" r="48401" b="43940"/>
          <a:stretch/>
        </p:blipFill>
        <p:spPr>
          <a:xfrm>
            <a:off x="2872035" y="4182039"/>
            <a:ext cx="1297641" cy="7395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555" t="39091" r="19601" b="43940"/>
          <a:stretch/>
        </p:blipFill>
        <p:spPr>
          <a:xfrm>
            <a:off x="4250357" y="4168592"/>
            <a:ext cx="1201272" cy="7530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/>
          <p:cNvSpPr txBox="1"/>
          <p:nvPr/>
        </p:nvSpPr>
        <p:spPr>
          <a:xfrm>
            <a:off x="5487489" y="4259581"/>
            <a:ext cx="10374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HC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407022" y="2082805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056961" y="2082805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680006" y="2082805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392697" y="2082805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988848" y="2082805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849709" y="1266430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3013278" y="2075331"/>
            <a:ext cx="9716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4349014" y="2079814"/>
            <a:ext cx="9716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3156686" y="1679406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215068" y="1685390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05893" y="275404"/>
            <a:ext cx="3275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f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545521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/>
          <a:srcRect l="13804"/>
          <a:stretch/>
        </p:blipFill>
        <p:spPr>
          <a:xfrm>
            <a:off x="3267635" y="2670920"/>
            <a:ext cx="1801905" cy="6286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5096436" y="2810433"/>
            <a:ext cx="11769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</a:t>
            </a:r>
            <a:endParaRPr lang="en-US" altLang="zh-CN" sz="1600" dirty="0" smtClean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4"/>
          <a:srcRect l="13803" b="30660"/>
          <a:stretch/>
        </p:blipFill>
        <p:spPr>
          <a:xfrm>
            <a:off x="3267635" y="3363724"/>
            <a:ext cx="1801904" cy="4821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/>
          <p:cNvSpPr txBox="1"/>
          <p:nvPr/>
        </p:nvSpPr>
        <p:spPr>
          <a:xfrm>
            <a:off x="5096436" y="3541054"/>
            <a:ext cx="1152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GFR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5"/>
          <a:srcRect l="13803" b="13941"/>
          <a:stretch/>
        </p:blipFill>
        <p:spPr>
          <a:xfrm>
            <a:off x="3267635" y="3887040"/>
            <a:ext cx="1801903" cy="6311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5096436" y="4177546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CBL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6"/>
          <a:srcRect l="13160" b="12003"/>
          <a:stretch/>
        </p:blipFill>
        <p:spPr>
          <a:xfrm>
            <a:off x="3267635" y="4565837"/>
            <a:ext cx="1801902" cy="7188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/>
          <p:cNvSpPr txBox="1"/>
          <p:nvPr/>
        </p:nvSpPr>
        <p:spPr>
          <a:xfrm>
            <a:off x="5096436" y="4854379"/>
            <a:ext cx="10150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HC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662517" y="2299446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312456" y="229944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720349" y="2299446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285123" y="2299446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693016" y="2299446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816234" y="279310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151092" y="294489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2820717" y="260932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3142128" y="2788018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2717624" y="346097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3160058" y="3612768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2744518" y="426779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3173505" y="443303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2722107" y="400333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3164541" y="415513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2802789" y="498496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6" name="直接连接符 35"/>
          <p:cNvCxnSpPr/>
          <p:nvPr/>
        </p:nvCxnSpPr>
        <p:spPr>
          <a:xfrm>
            <a:off x="3151094" y="513676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2793825" y="472050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3142130" y="487230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3609274" y="160056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3285562" y="2284756"/>
            <a:ext cx="68953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2999118" y="1960000"/>
            <a:ext cx="1208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Replicate 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4325464" y="2289239"/>
            <a:ext cx="68953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4186937" y="1977930"/>
            <a:ext cx="1208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Replicate 3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205893" y="275404"/>
            <a:ext cx="3916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f. Replicate 2 and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3222801" y="1960000"/>
            <a:ext cx="18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20070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05893" y="275404"/>
            <a:ext cx="3275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f. Replicate 4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69" t="43165" r="25757" b="43525"/>
          <a:stretch/>
        </p:blipFill>
        <p:spPr>
          <a:xfrm>
            <a:off x="3173506" y="2124635"/>
            <a:ext cx="1801906" cy="4975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942" t="41092" r="37550" b="43103"/>
          <a:stretch/>
        </p:blipFill>
        <p:spPr>
          <a:xfrm>
            <a:off x="3173507" y="2675965"/>
            <a:ext cx="1801906" cy="4975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 flipH="1">
            <a:off x="4975412" y="2104637"/>
            <a:ext cx="311971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GRB2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 flipH="1">
            <a:off x="4993342" y="2768023"/>
            <a:ext cx="13402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EGFR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61" t="37321" r="31189" b="47368"/>
          <a:stretch/>
        </p:blipFill>
        <p:spPr>
          <a:xfrm>
            <a:off x="3173507" y="3254190"/>
            <a:ext cx="1801906" cy="6406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/>
        </p:nvSpPr>
        <p:spPr>
          <a:xfrm flipH="1">
            <a:off x="5011272" y="3404515"/>
            <a:ext cx="13402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CBL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64" t="15278" r="33842" b="67361"/>
          <a:stretch/>
        </p:blipFill>
        <p:spPr>
          <a:xfrm>
            <a:off x="3173506" y="3975551"/>
            <a:ext cx="1801906" cy="6723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9"/>
          <p:cNvSpPr txBox="1"/>
          <p:nvPr/>
        </p:nvSpPr>
        <p:spPr>
          <a:xfrm flipH="1">
            <a:off x="5029202" y="4135136"/>
            <a:ext cx="13402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SHC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953527" y="1009604"/>
            <a:ext cx="267893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/>
          </a:p>
        </p:txBody>
      </p:sp>
      <p:sp>
        <p:nvSpPr>
          <p:cNvPr id="12" name="文本框 11"/>
          <p:cNvSpPr txBox="1"/>
          <p:nvPr/>
        </p:nvSpPr>
        <p:spPr>
          <a:xfrm>
            <a:off x="3301252" y="1425386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700071" y="1725569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336563" y="1743499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690668" y="1747982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031873" y="1402975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255442" y="1747982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609547" y="1752465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3298848" y="1777388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4231174" y="1768424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79954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452" y="1224041"/>
            <a:ext cx="6483096" cy="529742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05893" y="275404"/>
            <a:ext cx="4140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3f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890894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77</Words>
  <Application>Microsoft Office PowerPoint</Application>
  <PresentationFormat>全屏显示(4:3)</PresentationFormat>
  <Paragraphs>49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8</cp:revision>
  <dcterms:created xsi:type="dcterms:W3CDTF">2020-08-31T01:47:35Z</dcterms:created>
  <dcterms:modified xsi:type="dcterms:W3CDTF">2020-10-08T06:59:40Z</dcterms:modified>
</cp:coreProperties>
</file>